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53" r:id="rId2"/>
    <p:sldId id="352" r:id="rId3"/>
  </p:sldIdLst>
  <p:sldSz cx="7772400" cy="100584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80000"/>
    <a:srgbClr val="FF7F7F"/>
    <a:srgbClr val="203864"/>
    <a:srgbClr val="5799D5"/>
    <a:srgbClr val="7030A0"/>
    <a:srgbClr val="AA72D4"/>
    <a:srgbClr val="D9D9D9"/>
    <a:srgbClr val="385823"/>
    <a:srgbClr val="9DB4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1" autoAdjust="0"/>
    <p:restoredTop sz="94607" autoAdjust="0"/>
  </p:normalViewPr>
  <p:slideViewPr>
    <p:cSldViewPr snapToGrid="0" showGuides="1">
      <p:cViewPr varScale="1">
        <p:scale>
          <a:sx n="79" d="100"/>
          <a:sy n="79" d="100"/>
        </p:scale>
        <p:origin x="1116" y="90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22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4297-932A-4F71-8903-B6D1F1A62791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B4F4F-841E-4595-8617-427A2B050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796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015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AB7896EC-E3CD-4ADC-ADBD-BCB0E153EB35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3800" y="876300"/>
            <a:ext cx="18288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483" y="3373516"/>
            <a:ext cx="7435436" cy="2760584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015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B60371A-E4C3-41C0-9CCA-55B0B6D9B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35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01" indent="0" algn="ctr">
              <a:buNone/>
              <a:defRPr sz="1700"/>
            </a:lvl2pPr>
            <a:lvl3pPr marL="777202" indent="0" algn="ctr">
              <a:buNone/>
              <a:defRPr sz="1530"/>
            </a:lvl3pPr>
            <a:lvl4pPr marL="1165803" indent="0" algn="ctr">
              <a:buNone/>
              <a:defRPr sz="1360"/>
            </a:lvl4pPr>
            <a:lvl5pPr marL="1554404" indent="0" algn="ctr">
              <a:buNone/>
              <a:defRPr sz="1360"/>
            </a:lvl5pPr>
            <a:lvl6pPr marL="1943005" indent="0" algn="ctr">
              <a:buNone/>
              <a:defRPr sz="1360"/>
            </a:lvl6pPr>
            <a:lvl7pPr marL="2331606" indent="0" algn="ctr">
              <a:buNone/>
              <a:defRPr sz="1360"/>
            </a:lvl7pPr>
            <a:lvl8pPr marL="2720207" indent="0" algn="ctr">
              <a:buNone/>
              <a:defRPr sz="1360"/>
            </a:lvl8pPr>
            <a:lvl9pPr marL="3108808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6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4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2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0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02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03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0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0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60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20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8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7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65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5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81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0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01" indent="0">
              <a:buNone/>
              <a:defRPr sz="2380"/>
            </a:lvl2pPr>
            <a:lvl3pPr marL="777202" indent="0">
              <a:buNone/>
              <a:defRPr sz="2040"/>
            </a:lvl3pPr>
            <a:lvl4pPr marL="1165803" indent="0">
              <a:buNone/>
              <a:defRPr sz="1700"/>
            </a:lvl4pPr>
            <a:lvl5pPr marL="1554404" indent="0">
              <a:buNone/>
              <a:defRPr sz="1700"/>
            </a:lvl5pPr>
            <a:lvl6pPr marL="1943005" indent="0">
              <a:buNone/>
              <a:defRPr sz="1700"/>
            </a:lvl6pPr>
            <a:lvl7pPr marL="2331606" indent="0">
              <a:buNone/>
              <a:defRPr sz="1700"/>
            </a:lvl7pPr>
            <a:lvl8pPr marL="2720207" indent="0">
              <a:buNone/>
              <a:defRPr sz="1700"/>
            </a:lvl8pPr>
            <a:lvl9pPr marL="3108808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2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02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01" indent="-194301" algn="l" defTabSz="777202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02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04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305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5906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508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109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01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02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03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04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05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606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207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808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5313" y="531792"/>
            <a:ext cx="6703695" cy="638196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: Suppression of PDX1 is specific to targeting Area IV with Sa-dCas9/LSD1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chematics of the epigenetic engineering control Ad5 vectors generated for these studie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analysis of PDX1 expression after treatment with Sa-dCas9/LSD1 vectors expressing either the functional, but non-target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I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PCR analysis o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DX1 expression after targeting either Sa-dCas9 or Sa-dCas9/LSD1 to PDX1 Area IV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V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PCR analysis of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DX1 expression after treatment with Sa-dCas9 vectors that contain no gRNA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R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RNA</a:t>
            </a:r>
            <a:r>
              <a:rPr lang="en-US" sz="11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 I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mmunoblot analysis of Sa-dCas9 and Sa-dCas9/LSD1 transgene expression (i.e. HA tag) or endogenous PDX1 levels after treatment with the epigenetic engineering control Ad5 vectors depicted in panel A. For all experiments, INS1 832/13 cells were transduced with the indicated Ad5 vectors and harvested 48h later. Data represent mean ± S.E.M. of 4 independent experiments. #, p &lt; 0.05 compared to respective control adenovirus for each panel.</a:t>
            </a:r>
          </a:p>
        </p:txBody>
      </p:sp>
    </p:spTree>
    <p:extLst>
      <p:ext uri="{BB962C8B-B14F-4D97-AF65-F5344CB8AC3E}">
        <p14:creationId xmlns:p14="http://schemas.microsoft.com/office/powerpoint/2010/main" val="27602225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="" xmlns:a16="http://schemas.microsoft.com/office/drawing/2014/main" id="{FD84BD93-D558-4DF5-A382-1AFED119DD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1567" y="6495291"/>
            <a:ext cx="2060627" cy="353598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="" xmlns:a16="http://schemas.microsoft.com/office/drawing/2014/main" id="{C15B9910-1428-434A-A061-35E8CAB193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746" y="3079886"/>
            <a:ext cx="1632411" cy="352288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="" xmlns:a16="http://schemas.microsoft.com/office/drawing/2014/main" id="{0EF8D16B-3AFD-4B9B-B94F-52D20947C0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0633" y="905541"/>
            <a:ext cx="4217185" cy="1823920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7C18AB21-40BD-432B-A153-49463F8EBC9F}"/>
              </a:ext>
            </a:extLst>
          </p:cNvPr>
          <p:cNvSpPr txBox="1"/>
          <p:nvPr/>
        </p:nvSpPr>
        <p:spPr>
          <a:xfrm>
            <a:off x="278913" y="28398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6A141853-CAD7-42D6-BA83-88A2DE4B5B3F}"/>
              </a:ext>
            </a:extLst>
          </p:cNvPr>
          <p:cNvSpPr txBox="1"/>
          <p:nvPr/>
        </p:nvSpPr>
        <p:spPr>
          <a:xfrm>
            <a:off x="3873769" y="28398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125E6962-0FA0-42AE-9330-E48458AC8696}"/>
              </a:ext>
            </a:extLst>
          </p:cNvPr>
          <p:cNvSpPr txBox="1"/>
          <p:nvPr/>
        </p:nvSpPr>
        <p:spPr>
          <a:xfrm>
            <a:off x="278913" y="64481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125E6962-0FA0-42AE-9330-E48458AC8696}"/>
              </a:ext>
            </a:extLst>
          </p:cNvPr>
          <p:cNvSpPr txBox="1"/>
          <p:nvPr/>
        </p:nvSpPr>
        <p:spPr>
          <a:xfrm>
            <a:off x="3873769" y="644817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1226" y="3056468"/>
            <a:ext cx="1719221" cy="3535986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192ACE9F-99D0-4809-A704-5BE3A68F3805}"/>
              </a:ext>
            </a:extLst>
          </p:cNvPr>
          <p:cNvSpPr txBox="1"/>
          <p:nvPr/>
        </p:nvSpPr>
        <p:spPr>
          <a:xfrm>
            <a:off x="278913" y="79894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itle 1">
            <a:extLst>
              <a:ext uri="{FF2B5EF4-FFF2-40B4-BE49-F238E27FC236}">
                <a16:creationId xmlns="" xmlns:a16="http://schemas.microsoft.com/office/drawing/2014/main" id="{903913F7-9EFE-4C13-AE86-8270866F904A}"/>
              </a:ext>
            </a:extLst>
          </p:cNvPr>
          <p:cNvSpPr txBox="1">
            <a:spLocks/>
          </p:cNvSpPr>
          <p:nvPr/>
        </p:nvSpPr>
        <p:spPr>
          <a:xfrm>
            <a:off x="152400" y="274358"/>
            <a:ext cx="7772400" cy="63118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Supplemental Figure 5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672F8F8A-E4EF-412E-A649-ED8D564905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49458" y="6655432"/>
            <a:ext cx="3255546" cy="25483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004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7</TotalTime>
  <Words>195</Words>
  <Application>Microsoft Office PowerPoint</Application>
  <PresentationFormat>Custom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uk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Haldeman</dc:creator>
  <cp:lastModifiedBy>Jonathan Haldeman</cp:lastModifiedBy>
  <cp:revision>625</cp:revision>
  <cp:lastPrinted>2018-11-09T17:51:23Z</cp:lastPrinted>
  <dcterms:created xsi:type="dcterms:W3CDTF">2016-09-16T14:04:00Z</dcterms:created>
  <dcterms:modified xsi:type="dcterms:W3CDTF">2018-11-27T23:39:08Z</dcterms:modified>
</cp:coreProperties>
</file>